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5A4357-9F2F-4570-BC8A-EF0DD8F2EB6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FBB216-2634-4AF1-9A3A-3D15C5CD896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AAC125-B556-454B-A50D-E073C8963C2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58BE9D-92C8-40C6-8E14-725DD648EBE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8C878D-9B63-46AE-A58A-040421B3B9D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67027E-8FAE-4CCB-9AD6-37B6659E657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B2E07B-6D80-4C66-875B-AA9A6B5F17D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465160-9FFC-437A-ABB6-790AA7B109B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A8F0E5-7D22-40F8-BE44-A0BA9471B64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CFFA22-4C56-4D01-BBE9-0AC99B9B3C5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D7DDF3-C3F0-433C-97A8-2BE31601623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BAFEAB-7C9E-486E-A563-DA37F44517B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B40A5F2-7CB9-454A-B486-519D0A10DA4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4" descr=""/>
          <p:cNvPicPr/>
          <p:nvPr/>
        </p:nvPicPr>
        <p:blipFill>
          <a:blip r:embed="rId1"/>
          <a:stretch/>
        </p:blipFill>
        <p:spPr>
          <a:xfrm>
            <a:off x="430200" y="1009800"/>
            <a:ext cx="3538440" cy="154620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5" descr=""/>
          <p:cNvPicPr/>
          <p:nvPr/>
        </p:nvPicPr>
        <p:blipFill>
          <a:blip r:embed="rId2"/>
          <a:stretch/>
        </p:blipFill>
        <p:spPr>
          <a:xfrm>
            <a:off x="417600" y="2620800"/>
            <a:ext cx="3538440" cy="152568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6" descr=""/>
          <p:cNvPicPr/>
          <p:nvPr/>
        </p:nvPicPr>
        <p:blipFill>
          <a:blip r:embed="rId3"/>
          <a:stretch/>
        </p:blipFill>
        <p:spPr>
          <a:xfrm>
            <a:off x="430200" y="4211640"/>
            <a:ext cx="3538440" cy="1525680"/>
          </a:xfrm>
          <a:prstGeom prst="rect">
            <a:avLst/>
          </a:prstGeom>
          <a:ln w="0">
            <a:noFill/>
          </a:ln>
        </p:spPr>
      </p:pic>
      <p:sp>
        <p:nvSpPr>
          <p:cNvPr id="44" name="Text Box 8"/>
          <p:cNvSpPr/>
          <p:nvPr/>
        </p:nvSpPr>
        <p:spPr>
          <a:xfrm>
            <a:off x="4437000" y="1440000"/>
            <a:ext cx="1997280" cy="393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Additional file 5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. The logos for the three motif sequences of AACTGGAC, GAAACTGG and AACTGG identified in the upstream of the 65 specifically up-regulated PPR genes in 9804-</a:t>
            </a:r>
            <a:r>
              <a:rPr b="0" i="1" lang="en-US" sz="1800" spc="-1" strike="noStrike">
                <a:solidFill>
                  <a:srgbClr val="000000"/>
                </a:solidFill>
                <a:latin typeface="Times New Roman"/>
              </a:rPr>
              <a:t>Rxo1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induced by </a:t>
            </a:r>
            <a:r>
              <a:rPr b="0" i="1" lang="en-US" sz="1800" spc="-1" strike="noStrike">
                <a:solidFill>
                  <a:srgbClr val="000000"/>
                </a:solidFill>
                <a:latin typeface="Times New Roman"/>
              </a:rPr>
              <a:t>Xo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5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1-14T01:31:40Z</dcterms:created>
  <dc:creator>Zhou Yongli</dc:creator>
  <dc:description/>
  <dc:language>en-US</dc:language>
  <cp:lastModifiedBy>MC SYSTEM</cp:lastModifiedBy>
  <dcterms:modified xsi:type="dcterms:W3CDTF">2010-01-14T06:12:08Z</dcterms:modified>
  <cp:revision>76</cp:revision>
  <dc:subject/>
  <dc:title>幻灯片 1</dc:title>
</cp:coreProperties>
</file>